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5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6" y="2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NDO YUSUKE" userId="a477efb4f86a0ef6" providerId="LiveId" clId="{9DA99B73-DB06-4C7A-8F4A-BCD29E2448AB}"/>
    <pc:docChg chg="modSld">
      <pc:chgData name="KONDO YUSUKE" userId="a477efb4f86a0ef6" providerId="LiveId" clId="{9DA99B73-DB06-4C7A-8F4A-BCD29E2448AB}" dt="2024-03-07T21:16:14.362" v="1" actId="20577"/>
      <pc:docMkLst>
        <pc:docMk/>
      </pc:docMkLst>
      <pc:sldChg chg="modSp mod">
        <pc:chgData name="KONDO YUSUKE" userId="a477efb4f86a0ef6" providerId="LiveId" clId="{9DA99B73-DB06-4C7A-8F4A-BCD29E2448AB}" dt="2024-03-07T21:16:14.362" v="1" actId="20577"/>
        <pc:sldMkLst>
          <pc:docMk/>
          <pc:sldMk cId="2042828551" sldId="295"/>
        </pc:sldMkLst>
        <pc:spChg chg="mod">
          <ac:chgData name="KONDO YUSUKE" userId="a477efb4f86a0ef6" providerId="LiveId" clId="{9DA99B73-DB06-4C7A-8F4A-BCD29E2448AB}" dt="2024-03-07T21:16:14.362" v="1" actId="20577"/>
          <ac:spMkLst>
            <pc:docMk/>
            <pc:sldMk cId="2042828551" sldId="295"/>
            <ac:spMk id="3" creationId="{8F27B35E-A722-4217-8183-D303B31E41F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B3EF90-1DC7-4FA6-B42D-10FC64C764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D4EF394-1797-4410-B96B-47589821EE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44EDB1-B6F8-4255-ABBC-E317811E2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337D9A-6A20-4AC5-A20B-1705A8850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FABD16-1966-44DD-AEAA-C46F3FAE1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2692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206E5A-EF9E-4806-9B58-917054D49F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2D276D-7C41-4DA6-B0B0-2E795A132A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E03F6CE-7764-4CCB-B91B-F0456C236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7A6905-07C8-433B-BFA2-19E8DB9C2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605CFA-6D6A-425D-9103-2C33F2653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6455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AFF2AB3-C245-4C44-A5A8-48E0AD10E4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18D9D87-D6AB-4916-912C-88056E76E9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217458-BCFF-4F0A-9171-20CBC8BF1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C8118B-827A-4F0B-9E1D-86296C2D6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3D3F6D-3191-4291-A58C-FF8F755E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3474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33D4A9-3DF5-48F9-B280-246C39DD7E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A71956-92B4-4A96-B6EE-997656E192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7D3553-45BB-4A8A-AFAB-64F8964FF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B6721F-8E71-421F-A909-5F587821E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27A96C-444B-4302-9A80-BC36C9CF1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856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11F51E-EE9C-453C-8998-BFE2A04A46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05ED73-F7D5-489D-9077-ED3927D698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948C10-57C9-409E-98DF-9C98B00A7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AD5214-3577-455C-B478-F25F2DAB9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A80035-E937-4719-BC0E-CAAFFEC14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9945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6534E6-2820-4ADB-8BCF-D2DCD66AC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1DE82EF-36A5-4452-80BF-97618B360E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D8A93A5-9C99-4E14-B27E-26B4C81ABB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E163F42-E650-4075-810D-658EA2BC3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A48E372-47B0-4C86-82B6-5A8B21BBC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8564A0-B183-43A7-8B92-520BD1C0F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717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B26353-25C4-43FE-AF86-FBD3210A9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CDBABB-233E-40B9-94E4-44FB92EF7C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F01FBA3-BEAA-4D94-A23C-D509E7D782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D3C3D35-1229-41F9-B6EF-1E6BA0EE5A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720284D-5E09-4768-9172-9520450BBC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49A285E-BFFA-4378-9E3B-C2D78D61D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7881425-C712-46FF-9257-9F167590A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D1E2A11-F00D-4B53-83F0-644469424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6578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00E2D9-DBF3-49EC-A0DA-FFE342852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4881C46-87D5-4B60-8CA3-C881505F8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6119E6B-3785-40AA-B40C-32F4DCC63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8CC2E5-EF26-4519-930E-7DD5F220E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7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0F845A5-CA74-4964-9581-EC26CED5E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2481FBB-BC1B-4605-BA07-42C3B40F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1EAF2DC-BBFB-4A69-AE48-73639315B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777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08E153-9780-47A7-BA45-CD3A45DE1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044F476-2B05-48A3-8023-9B3B193160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6E908E5-967C-4728-B9C6-C87E3DD779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C4F59B-E72B-446E-8947-651854638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2344A4-19A9-48ED-AA4A-3A15CE098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10766B0-00FA-44AA-A1B7-596B960F3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27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D4C7F6-8AA1-4461-8D9B-2673337D9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B32CF77-267D-4AF9-B6D4-797334CC14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274E87C-F1AC-482A-861D-03D775BD18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859B70-AEE0-4185-9ACA-9B9ADCBCE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EA6FD4E-BF01-445E-BBEC-EE14E86A6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8FD1890-677F-4780-8C3A-14F28A831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652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41DCD4E-4089-41C0-A40C-D4D08CCB5B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733116C-BA18-463C-800C-65A86C6C64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8D633B-AF18-4D36-A2D2-A7B7BC0729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F2775-6C4E-49B6-B4F3-FF66CFCA2948}" type="datetimeFigureOut">
              <a:rPr kumimoji="1" lang="ja-JP" altLang="en-US" smtClean="0"/>
              <a:t>2024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9A547C-7CEA-4B10-BFEA-5DB4C6A8EF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C9CE96-7899-4357-82A4-5235D21158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9F807-3838-4067-89A1-2D22DFD223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404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5">
            <a:extLst>
              <a:ext uri="{FF2B5EF4-FFF2-40B4-BE49-F238E27FC236}">
                <a16:creationId xmlns:a16="http://schemas.microsoft.com/office/drawing/2014/main" id="{FE5E2A3C-B3CC-8B4B-860D-4A842F1F9E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4874771"/>
              </p:ext>
            </p:extLst>
          </p:nvPr>
        </p:nvGraphicFramePr>
        <p:xfrm>
          <a:off x="525517" y="491318"/>
          <a:ext cx="11330152" cy="403889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493876">
                  <a:extLst>
                    <a:ext uri="{9D8B030D-6E8A-4147-A177-3AD203B41FA5}">
                      <a16:colId xmlns:a16="http://schemas.microsoft.com/office/drawing/2014/main" val="185285012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859818344"/>
                    </a:ext>
                  </a:extLst>
                </a:gridCol>
                <a:gridCol w="1303283">
                  <a:extLst>
                    <a:ext uri="{9D8B030D-6E8A-4147-A177-3AD203B41FA5}">
                      <a16:colId xmlns:a16="http://schemas.microsoft.com/office/drawing/2014/main" val="2387056937"/>
                    </a:ext>
                  </a:extLst>
                </a:gridCol>
                <a:gridCol w="1250731">
                  <a:extLst>
                    <a:ext uri="{9D8B030D-6E8A-4147-A177-3AD203B41FA5}">
                      <a16:colId xmlns:a16="http://schemas.microsoft.com/office/drawing/2014/main" val="3376268304"/>
                    </a:ext>
                  </a:extLst>
                </a:gridCol>
              </a:tblGrid>
              <a:tr h="3524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Recommendations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JCS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ACC/AHA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ESC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1698863"/>
                  </a:ext>
                </a:extLst>
              </a:tr>
              <a:tr h="792917"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CRT</a:t>
                      </a:r>
                    </a:p>
                    <a:p>
                      <a:r>
                        <a:rPr kumimoji="1" lang="en-US" altLang="ja-JP" sz="1200" dirty="0"/>
                        <a:t>    CRT is recommended for symptomatic patients with HF in sinus rhythm with a QRS duration</a:t>
                      </a:r>
                    </a:p>
                    <a:p>
                      <a:r>
                        <a:rPr kumimoji="1" lang="en-US" altLang="ja-JP" sz="1200" dirty="0"/>
                        <a:t>          </a:t>
                      </a:r>
                      <a:r>
                        <a:rPr kumimoji="1" lang="ja-JP" altLang="en-US" sz="1200" dirty="0"/>
                        <a:t>≧</a:t>
                      </a:r>
                      <a:r>
                        <a:rPr kumimoji="1" lang="en-US" altLang="ja-JP" sz="1200" dirty="0"/>
                        <a:t>150</a:t>
                      </a:r>
                      <a:r>
                        <a:rPr kumimoji="1" lang="ja-JP" altLang="en-US" sz="1200" dirty="0"/>
                        <a:t> </a:t>
                      </a:r>
                      <a:r>
                        <a:rPr kumimoji="1" lang="en-US" altLang="ja-JP" sz="1200" dirty="0" err="1"/>
                        <a:t>ms</a:t>
                      </a:r>
                      <a:r>
                        <a:rPr kumimoji="1" lang="en-US" altLang="ja-JP" sz="1200" dirty="0"/>
                        <a:t> and LBBB QRS morphology and with LVEF </a:t>
                      </a:r>
                      <a:r>
                        <a:rPr kumimoji="1" lang="ja-JP" altLang="en-US" sz="1200" dirty="0"/>
                        <a:t>≦</a:t>
                      </a:r>
                      <a:r>
                        <a:rPr kumimoji="1" lang="en-US" altLang="ja-JP" sz="1200" dirty="0"/>
                        <a:t>35</a:t>
                      </a:r>
                      <a:r>
                        <a:rPr kumimoji="1" lang="ja-JP" altLang="en-US" sz="1200" dirty="0"/>
                        <a:t>％</a:t>
                      </a:r>
                      <a:r>
                        <a:rPr kumimoji="1" lang="en-US" altLang="ja-JP" sz="1200" dirty="0"/>
                        <a:t> despite OMT in order to</a:t>
                      </a:r>
                    </a:p>
                    <a:p>
                      <a:r>
                        <a:rPr kumimoji="1" lang="en-US" altLang="ja-JP" sz="1200" dirty="0"/>
                        <a:t>           improve symptoms and reduce morbidity and mortality.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Ⅰ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kumimoji="1" lang="en-US" altLang="ja-JP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Ⅰ</a:t>
                      </a:r>
                      <a:endParaRPr kumimoji="1" lang="ja-JP" alt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/>
                        <a:t>Ⅰ</a:t>
                      </a:r>
                      <a:endParaRPr kumimoji="1" lang="ja-JP" altLang="en-US" dirty="0"/>
                    </a:p>
                    <a:p>
                      <a:pPr algn="ctr"/>
                      <a:endParaRPr kumimoji="1" lang="ja-JP" alt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158807"/>
                  </a:ext>
                </a:extLst>
              </a:tr>
              <a:tr h="693569"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    CRT should be considered for symptomatic patients with HF in sinus rhythm with a QRS duration </a:t>
                      </a:r>
                    </a:p>
                    <a:p>
                      <a:r>
                        <a:rPr kumimoji="1" lang="en-US" altLang="ja-JP" sz="1200" dirty="0"/>
                        <a:t>          </a:t>
                      </a:r>
                      <a:r>
                        <a:rPr kumimoji="1" lang="ja-JP" altLang="en-US" sz="1200"/>
                        <a:t>≧</a:t>
                      </a:r>
                      <a:r>
                        <a:rPr kumimoji="1" lang="en-US" altLang="ja-JP" sz="1200" dirty="0"/>
                        <a:t>150</a:t>
                      </a:r>
                      <a:r>
                        <a:rPr kumimoji="1" lang="ja-JP" altLang="en-US" sz="1200"/>
                        <a:t> </a:t>
                      </a:r>
                      <a:r>
                        <a:rPr kumimoji="1" lang="en-US" altLang="ja-JP" sz="1200" dirty="0" err="1"/>
                        <a:t>ms</a:t>
                      </a:r>
                      <a:r>
                        <a:rPr kumimoji="1" lang="en-US" altLang="ja-JP" sz="1200" dirty="0"/>
                        <a:t> and non-LBBB QRS morphology and with LVEF </a:t>
                      </a:r>
                      <a:r>
                        <a:rPr kumimoji="1" lang="ja-JP" altLang="en-US" sz="1200"/>
                        <a:t>≦</a:t>
                      </a:r>
                      <a:r>
                        <a:rPr kumimoji="1" lang="en-US" altLang="ja-JP" sz="1200" dirty="0"/>
                        <a:t>35% despite OMT in order to</a:t>
                      </a:r>
                    </a:p>
                    <a:p>
                      <a:r>
                        <a:rPr kumimoji="1" lang="en-US" altLang="ja-JP" sz="1200" dirty="0"/>
                        <a:t>           improve symptoms and reduce morbidity and mortality.</a:t>
                      </a:r>
                      <a:endParaRPr kumimoji="1" lang="ja-JP" altLang="en-US" sz="120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Ⅱa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kumimoji="1" lang="ja-JP" altLang="en-US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Ⅱb</a:t>
                      </a:r>
                      <a:endParaRPr kumimoji="1" lang="ja-JP" alt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Ⅱa</a:t>
                      </a:r>
                      <a:endParaRPr kumimoji="1" lang="ja-JP" alt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4269760"/>
                  </a:ext>
                </a:extLst>
              </a:tr>
              <a:tr h="704815"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    CRT is recommended for symptomatic patients with HF in sinus rhythm with a QRS durations of</a:t>
                      </a:r>
                    </a:p>
                    <a:p>
                      <a:r>
                        <a:rPr kumimoji="1" lang="en-US" altLang="ja-JP" sz="1200" dirty="0"/>
                        <a:t>          130-149 ns and LBBB QRS morphology and with LVEF </a:t>
                      </a:r>
                      <a:r>
                        <a:rPr kumimoji="1" lang="ja-JP" altLang="en-US" sz="1200"/>
                        <a:t>≦</a:t>
                      </a:r>
                      <a:r>
                        <a:rPr kumimoji="1" lang="en-US" altLang="ja-JP" sz="1200" dirty="0"/>
                        <a:t>35% despite OMT in order to</a:t>
                      </a:r>
                    </a:p>
                    <a:p>
                      <a:r>
                        <a:rPr kumimoji="1" lang="en-US" altLang="ja-JP" sz="1200" dirty="0"/>
                        <a:t>           improve symptoms and reduce morbidity and mortality.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Ⅰ</a:t>
                      </a:r>
                      <a:endParaRPr kumimoji="1" lang="en-US" altLang="ja-JP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(QRS duration: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120-149 </a:t>
                      </a:r>
                      <a:r>
                        <a:rPr kumimoji="1" lang="en-US" altLang="ja-JP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ms</a:t>
                      </a: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kumimoji="1" lang="en-US" altLang="ja-JP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/>
                        <a:t>Ⅱb</a:t>
                      </a:r>
                      <a:endParaRPr kumimoji="1" lang="ja-JP" altLang="en-US" dirty="0"/>
                    </a:p>
                    <a:p>
                      <a:pPr algn="ctr"/>
                      <a:r>
                        <a:rPr kumimoji="1" lang="en-US" altLang="ja-JP" sz="1200" dirty="0"/>
                        <a:t>(QRS duration:</a:t>
                      </a:r>
                    </a:p>
                    <a:p>
                      <a:pPr algn="ctr"/>
                      <a:r>
                        <a:rPr kumimoji="1" lang="en-US" altLang="ja-JP" sz="1200" dirty="0"/>
                        <a:t>120-149 </a:t>
                      </a:r>
                      <a:r>
                        <a:rPr kumimoji="1" lang="en-US" altLang="ja-JP" sz="1200" dirty="0" err="1"/>
                        <a:t>ms</a:t>
                      </a:r>
                      <a:r>
                        <a:rPr kumimoji="1" lang="en-US" altLang="ja-JP" sz="1200" dirty="0"/>
                        <a:t>)</a:t>
                      </a:r>
                      <a:endParaRPr kumimoji="1" lang="ja-JP" altLang="en-US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/>
                        <a:t>Ⅰ</a:t>
                      </a:r>
                      <a:endParaRPr kumimoji="1" lang="ja-JP" altLang="en-US" dirty="0"/>
                    </a:p>
                    <a:p>
                      <a:pPr algn="ctr"/>
                      <a:r>
                        <a:rPr kumimoji="1" lang="en-US" altLang="ja-JP" sz="1200" dirty="0"/>
                        <a:t>(QRS duration:</a:t>
                      </a:r>
                    </a:p>
                    <a:p>
                      <a:pPr algn="ctr"/>
                      <a:r>
                        <a:rPr kumimoji="1" lang="en-US" altLang="ja-JP" sz="1200" dirty="0"/>
                        <a:t> 130-149 </a:t>
                      </a:r>
                      <a:r>
                        <a:rPr kumimoji="1" lang="en-US" altLang="ja-JP" sz="1200" dirty="0" err="1"/>
                        <a:t>ms</a:t>
                      </a:r>
                      <a:r>
                        <a:rPr kumimoji="1" lang="en-US" altLang="ja-JP" sz="1200" dirty="0"/>
                        <a:t>)</a:t>
                      </a:r>
                      <a:endParaRPr kumimoji="1" lang="ja-JP" altLang="en-US" sz="1200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2370421"/>
                  </a:ext>
                </a:extLst>
              </a:tr>
              <a:tr h="704815"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    CRT may be considered for symptomatic patients with HF in sinus rhythm with a QRS duration of</a:t>
                      </a:r>
                    </a:p>
                    <a:p>
                      <a:r>
                        <a:rPr kumimoji="1" lang="en-US" altLang="ja-JP" sz="1200" dirty="0"/>
                        <a:t>            130-149 </a:t>
                      </a:r>
                      <a:r>
                        <a:rPr kumimoji="1" lang="en-US" altLang="ja-JP" sz="1200" dirty="0" err="1"/>
                        <a:t>ms</a:t>
                      </a:r>
                      <a:r>
                        <a:rPr kumimoji="1" lang="en-US" altLang="ja-JP" sz="1200" dirty="0"/>
                        <a:t> and non-LBBB QRS morphology and with LVEF </a:t>
                      </a:r>
                      <a:r>
                        <a:rPr kumimoji="1" lang="ja-JP" altLang="en-US" sz="1200" dirty="0"/>
                        <a:t>≦</a:t>
                      </a:r>
                      <a:r>
                        <a:rPr kumimoji="1" lang="en-US" altLang="ja-JP" sz="1200" dirty="0"/>
                        <a:t>35% despite OMT in order to</a:t>
                      </a:r>
                    </a:p>
                    <a:p>
                      <a:r>
                        <a:rPr kumimoji="1" lang="en-US" altLang="ja-JP" sz="1200" dirty="0"/>
                        <a:t>             improve symptoms and reduce morbidity and mortality.</a:t>
                      </a:r>
                      <a:endParaRPr kumimoji="1" lang="ja-JP" altLang="en-US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Ⅱb</a:t>
                      </a:r>
                      <a:endParaRPr kumimoji="1" lang="ja-JP" alt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(QRS duration: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120-149 </a:t>
                      </a:r>
                      <a:r>
                        <a:rPr kumimoji="1" lang="en-US" altLang="ja-JP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ms</a:t>
                      </a: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kumimoji="1" lang="ja-JP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Ⅲ</a:t>
                      </a:r>
                      <a:endParaRPr kumimoji="1" lang="ja-JP" alt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 err="1"/>
                        <a:t>Ⅱb</a:t>
                      </a:r>
                      <a:endParaRPr kumimoji="1" lang="ja-JP" altLang="en-US" dirty="0"/>
                    </a:p>
                    <a:p>
                      <a:pPr algn="ctr"/>
                      <a:endParaRPr kumimoji="1" lang="ja-JP" alt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5796274"/>
                  </a:ext>
                </a:extLst>
              </a:tr>
              <a:tr h="693569">
                <a:tc>
                  <a:txBody>
                    <a:bodyPr/>
                    <a:lstStyle/>
                    <a:p>
                      <a:r>
                        <a:rPr kumimoji="1" lang="en-US" altLang="ja-JP" sz="1200" dirty="0"/>
                        <a:t>    CRT is contraindicated in patients with a QRS duration </a:t>
                      </a:r>
                      <a:r>
                        <a:rPr kumimoji="1" lang="ja-JP" altLang="en-US" sz="1200" dirty="0"/>
                        <a:t>＜</a:t>
                      </a:r>
                      <a:r>
                        <a:rPr kumimoji="1" lang="en-US" altLang="ja-JP" sz="1200" dirty="0"/>
                        <a:t>130 </a:t>
                      </a:r>
                      <a:r>
                        <a:rPr kumimoji="1" lang="en-US" altLang="ja-JP" sz="1200" dirty="0" err="1"/>
                        <a:t>ms.</a:t>
                      </a:r>
                      <a:endParaRPr kumimoji="1" lang="ja-JP" altLang="en-US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/>
                        <a:t>Ⅲ</a:t>
                      </a:r>
                      <a:endParaRPr kumimoji="1" lang="ja-JP" altLang="en-US" dirty="0"/>
                    </a:p>
                    <a:p>
                      <a:pPr algn="ctr"/>
                      <a:endParaRPr kumimoji="1" lang="ja-JP" alt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3723280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F27B35E-A722-4217-8183-D303B31E41F4}"/>
              </a:ext>
            </a:extLst>
          </p:cNvPr>
          <p:cNvSpPr txBox="1"/>
          <p:nvPr/>
        </p:nvSpPr>
        <p:spPr>
          <a:xfrm>
            <a:off x="525517" y="5125416"/>
            <a:ext cx="1555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2828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3</TotalTime>
  <Words>245</Words>
  <Application>Microsoft Office PowerPoint</Application>
  <PresentationFormat>ワイド画面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SUKE KONDO</dc:creator>
  <cp:lastModifiedBy>KONDO YUSUKE</cp:lastModifiedBy>
  <cp:revision>45</cp:revision>
  <cp:lastPrinted>2020-12-10T00:37:53Z</cp:lastPrinted>
  <dcterms:created xsi:type="dcterms:W3CDTF">2020-12-03T02:50:18Z</dcterms:created>
  <dcterms:modified xsi:type="dcterms:W3CDTF">2024-03-07T21:16:16Z</dcterms:modified>
</cp:coreProperties>
</file>